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58" r:id="rId3"/>
    <p:sldId id="257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F21DA3B-0764-42B3-B542-9955970FAF81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455E8F7-B229-4043-8F54-CAC6BC86E04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26102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65BE2C6-BB27-482E-AE6B-C2AA4153DC40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1013571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29FDC-D363-40FB-B507-C579E9701B90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53056-7D79-4165-BC9F-7EC6FC6AC2A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33212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29FDC-D363-40FB-B507-C579E9701B90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53056-7D79-4165-BC9F-7EC6FC6AC2A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7638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29FDC-D363-40FB-B507-C579E9701B90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53056-7D79-4165-BC9F-7EC6FC6AC2A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5861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29FDC-D363-40FB-B507-C579E9701B90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53056-7D79-4165-BC9F-7EC6FC6AC2A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70332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29FDC-D363-40FB-B507-C579E9701B90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53056-7D79-4165-BC9F-7EC6FC6AC2A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696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29FDC-D363-40FB-B507-C579E9701B90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53056-7D79-4165-BC9F-7EC6FC6AC2A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3675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29FDC-D363-40FB-B507-C579E9701B90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53056-7D79-4165-BC9F-7EC6FC6AC2A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2114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29FDC-D363-40FB-B507-C579E9701B90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53056-7D79-4165-BC9F-7EC6FC6AC2A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890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29FDC-D363-40FB-B507-C579E9701B90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53056-7D79-4165-BC9F-7EC6FC6AC2A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2259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29FDC-D363-40FB-B507-C579E9701B90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53056-7D79-4165-BC9F-7EC6FC6AC2A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84573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29FDC-D363-40FB-B507-C579E9701B90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53056-7D79-4165-BC9F-7EC6FC6AC2A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10805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C29FDC-D363-40FB-B507-C579E9701B90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453056-7D79-4165-BC9F-7EC6FC6AC2A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96205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13" Type="http://schemas.openxmlformats.org/officeDocument/2006/relationships/image" Target="../media/image10.jpeg"/><Relationship Id="rId3" Type="http://schemas.openxmlformats.org/officeDocument/2006/relationships/image" Target="../media/image1.tiff"/><Relationship Id="rId7" Type="http://schemas.openxmlformats.org/officeDocument/2006/relationships/image" Target="../media/image4.jpeg"/><Relationship Id="rId12" Type="http://schemas.openxmlformats.org/officeDocument/2006/relationships/image" Target="../media/image9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11" Type="http://schemas.openxmlformats.org/officeDocument/2006/relationships/image" Target="../media/image8.jpeg"/><Relationship Id="rId5" Type="http://schemas.openxmlformats.org/officeDocument/2006/relationships/image" Target="../media/image3.png"/><Relationship Id="rId15" Type="http://schemas.openxmlformats.org/officeDocument/2006/relationships/image" Target="../media/image12.jpeg"/><Relationship Id="rId10" Type="http://schemas.openxmlformats.org/officeDocument/2006/relationships/image" Target="../media/image7.jpeg"/><Relationship Id="rId4" Type="http://schemas.openxmlformats.org/officeDocument/2006/relationships/image" Target="../media/image2.jpeg"/><Relationship Id="rId9" Type="http://schemas.openxmlformats.org/officeDocument/2006/relationships/image" Target="../media/image6.jpeg"/><Relationship Id="rId14" Type="http://schemas.openxmlformats.org/officeDocument/2006/relationships/image" Target="../media/image11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de-DE" dirty="0" err="1" smtClean="0"/>
              <a:t>Supplementary</a:t>
            </a:r>
            <a:r>
              <a:rPr lang="de-DE" dirty="0" smtClean="0"/>
              <a:t> Material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122984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Grafik 35">
            <a:extLst>
              <a:ext uri="{FF2B5EF4-FFF2-40B4-BE49-F238E27FC236}">
                <a16:creationId xmlns:a16="http://schemas.microsoft.com/office/drawing/2014/main" id="{DA0FE40C-C49F-4D6E-82AF-9F705301072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817" t="12333" r="16835" b="47725"/>
          <a:stretch/>
        </p:blipFill>
        <p:spPr>
          <a:xfrm>
            <a:off x="8993924" y="2238821"/>
            <a:ext cx="830583" cy="111834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35" name="Rectangle 34"/>
          <p:cNvSpPr/>
          <p:nvPr/>
        </p:nvSpPr>
        <p:spPr>
          <a:xfrm>
            <a:off x="8909777" y="3429966"/>
            <a:ext cx="1107059" cy="346036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7897090" y="3429966"/>
            <a:ext cx="1031147" cy="345082"/>
          </a:xfrm>
          <a:prstGeom prst="rect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3" name="Rectangle 32"/>
          <p:cNvSpPr/>
          <p:nvPr/>
        </p:nvSpPr>
        <p:spPr>
          <a:xfrm>
            <a:off x="6641868" y="3429012"/>
            <a:ext cx="1255221" cy="345185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2" name="Rectangle 31"/>
          <p:cNvSpPr/>
          <p:nvPr/>
        </p:nvSpPr>
        <p:spPr>
          <a:xfrm>
            <a:off x="4480560" y="3429012"/>
            <a:ext cx="2161307" cy="343062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1" name="Rectangle 30"/>
          <p:cNvSpPr/>
          <p:nvPr/>
        </p:nvSpPr>
        <p:spPr>
          <a:xfrm>
            <a:off x="3151207" y="3429012"/>
            <a:ext cx="1326077" cy="34306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9" name="Content Placeholder 8"/>
          <p:cNvPicPr>
            <a:picLocks noGrp="1" noChangeAspect="1"/>
          </p:cNvPicPr>
          <p:nvPr>
            <p:ph idx="1"/>
          </p:nvPr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1169" y="1795574"/>
            <a:ext cx="2133299" cy="1599975"/>
          </a:xfrm>
          <a:ln w="19050">
            <a:solidFill>
              <a:schemeClr val="tx1"/>
            </a:solidFill>
          </a:ln>
        </p:spPr>
      </p:pic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B1CA625F-CBE5-4FDD-B848-80D101F2E1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9367058" y="6565314"/>
            <a:ext cx="2743200" cy="365125"/>
          </a:xfrm>
        </p:spPr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70F22EF-14A0-4096-B9A8-047100ACD592}" type="slidenum"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1950172" y="3873145"/>
            <a:ext cx="8370916" cy="0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3151207" y="1307957"/>
            <a:ext cx="13928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egermination of seeds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999" t="49818" r="28001" b="19515"/>
          <a:stretch/>
        </p:blipFill>
        <p:spPr>
          <a:xfrm>
            <a:off x="3255960" y="2238821"/>
            <a:ext cx="1072343" cy="107234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3" name="TextBox 12"/>
          <p:cNvSpPr txBox="1"/>
          <p:nvPr/>
        </p:nvSpPr>
        <p:spPr>
          <a:xfrm>
            <a:off x="5786229" y="1307056"/>
            <a:ext cx="10659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ransfer in neopren rings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5647684" y="2387350"/>
            <a:ext cx="1108363" cy="83127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5" name="TextBox 14"/>
          <p:cNvSpPr txBox="1"/>
          <p:nvPr/>
        </p:nvSpPr>
        <p:spPr>
          <a:xfrm>
            <a:off x="4389045" y="1307957"/>
            <a:ext cx="162098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eparation of Hoagland solution for hydroponic boxes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735411" y="1309179"/>
            <a:ext cx="140140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pplication of drought stress via PEG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467872" y="3450475"/>
            <a:ext cx="11845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0 DAS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199536" y="3446654"/>
            <a:ext cx="11845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5 DAS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6679283" y="3442976"/>
            <a:ext cx="12178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2/19/26 DAS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8014518" y="1300769"/>
            <a:ext cx="7980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arvest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8017106" y="3441869"/>
            <a:ext cx="10461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3 DAS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8928238" y="1312939"/>
            <a:ext cx="13928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oot analysis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via WinRhizo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9071617" y="3448784"/>
            <a:ext cx="12021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4 DAS</a:t>
            </a:r>
            <a:endParaRPr kumimoji="0" 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7849512" y="2378614"/>
            <a:ext cx="1118347" cy="83876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340" r="1573"/>
          <a:stretch/>
        </p:blipFill>
        <p:spPr>
          <a:xfrm>
            <a:off x="4638621" y="2262064"/>
            <a:ext cx="819323" cy="107641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6704482" y="2384002"/>
            <a:ext cx="1112189" cy="83414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30" name="Rectangle 29"/>
          <p:cNvSpPr/>
          <p:nvPr/>
        </p:nvSpPr>
        <p:spPr>
          <a:xfrm>
            <a:off x="3151206" y="3970289"/>
            <a:ext cx="1326077" cy="328761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accent4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7" name="Rectangle 36"/>
          <p:cNvSpPr/>
          <p:nvPr/>
        </p:nvSpPr>
        <p:spPr>
          <a:xfrm>
            <a:off x="4482065" y="3970289"/>
            <a:ext cx="1304164" cy="329982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accent4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8" name="Rectangle 37"/>
          <p:cNvSpPr/>
          <p:nvPr/>
        </p:nvSpPr>
        <p:spPr>
          <a:xfrm>
            <a:off x="5786229" y="3970289"/>
            <a:ext cx="2110860" cy="328761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>
            <a:solidFill>
              <a:schemeClr val="accent4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9" name="Rectangle 38"/>
          <p:cNvSpPr/>
          <p:nvPr/>
        </p:nvSpPr>
        <p:spPr>
          <a:xfrm>
            <a:off x="7897089" y="3970289"/>
            <a:ext cx="1012688" cy="328762"/>
          </a:xfrm>
          <a:prstGeom prst="rect">
            <a:avLst/>
          </a:prstGeom>
          <a:solidFill>
            <a:schemeClr val="accent4"/>
          </a:solidFill>
          <a:ln>
            <a:solidFill>
              <a:schemeClr val="accent4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1" name="Rectangle 40"/>
          <p:cNvSpPr/>
          <p:nvPr/>
        </p:nvSpPr>
        <p:spPr>
          <a:xfrm>
            <a:off x="8918081" y="3970289"/>
            <a:ext cx="1098755" cy="328761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solidFill>
              <a:schemeClr val="accent4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480712" y="3969068"/>
            <a:ext cx="11845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0 DAS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4806789" y="3980780"/>
            <a:ext cx="11845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5 DAS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6437971" y="3981593"/>
            <a:ext cx="9384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5 -32 DAS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3151206" y="5591686"/>
            <a:ext cx="13928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egermination of seeds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46" name="Picture 45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999" t="49818" r="28001" b="19515"/>
          <a:stretch/>
        </p:blipFill>
        <p:spPr>
          <a:xfrm>
            <a:off x="3255960" y="4448784"/>
            <a:ext cx="1136894" cy="1136893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47" name="Picture 46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199" b="11023"/>
          <a:stretch/>
        </p:blipFill>
        <p:spPr>
          <a:xfrm>
            <a:off x="4696732" y="4447252"/>
            <a:ext cx="874829" cy="112943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48" name="TextBox 47"/>
          <p:cNvSpPr txBox="1"/>
          <p:nvPr/>
        </p:nvSpPr>
        <p:spPr>
          <a:xfrm>
            <a:off x="4544070" y="5591686"/>
            <a:ext cx="130162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ransfer in pots with sand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8017106" y="3969067"/>
            <a:ext cx="10461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3 DAS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9063230" y="3973736"/>
            <a:ext cx="12021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4 DAS</a:t>
            </a:r>
            <a:endParaRPr kumimoji="0" 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51" name="Picture 50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970"/>
          <a:stretch/>
        </p:blipFill>
        <p:spPr>
          <a:xfrm>
            <a:off x="9026520" y="4431439"/>
            <a:ext cx="824840" cy="116024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52" name="TextBox 51"/>
          <p:cNvSpPr txBox="1"/>
          <p:nvPr/>
        </p:nvSpPr>
        <p:spPr>
          <a:xfrm>
            <a:off x="8918081" y="5597350"/>
            <a:ext cx="13928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oot analysis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via WinRhizo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53" name="Picture 5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7844275" y="4581252"/>
            <a:ext cx="1160246" cy="87018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54" name="TextBox 53"/>
          <p:cNvSpPr txBox="1"/>
          <p:nvPr/>
        </p:nvSpPr>
        <p:spPr>
          <a:xfrm>
            <a:off x="8017241" y="5596468"/>
            <a:ext cx="7980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arvest</a:t>
            </a:r>
          </a:p>
        </p:txBody>
      </p:sp>
      <p:pic>
        <p:nvPicPr>
          <p:cNvPr id="55" name="Picture 54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364" b="27757"/>
          <a:stretch/>
        </p:blipFill>
        <p:spPr>
          <a:xfrm>
            <a:off x="5854319" y="4447309"/>
            <a:ext cx="996671" cy="112938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6" name="Picture 55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260" b="397"/>
          <a:stretch/>
        </p:blipFill>
        <p:spPr>
          <a:xfrm>
            <a:off x="7009227" y="4447252"/>
            <a:ext cx="773175" cy="112938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57" name="TextBox 56"/>
          <p:cNvSpPr txBox="1"/>
          <p:nvPr/>
        </p:nvSpPr>
        <p:spPr>
          <a:xfrm>
            <a:off x="5786229" y="5599069"/>
            <a:ext cx="203604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eparation of Hoagland solution for watering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rought stress 12-32 DAS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879" b="25818"/>
          <a:stretch/>
        </p:blipFill>
        <p:spPr>
          <a:xfrm>
            <a:off x="601169" y="4355678"/>
            <a:ext cx="2141807" cy="175922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59" name="TextBox 58"/>
          <p:cNvSpPr txBox="1"/>
          <p:nvPr/>
        </p:nvSpPr>
        <p:spPr>
          <a:xfrm>
            <a:off x="1100206" y="3395549"/>
            <a:ext cx="13928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ydroponics</a:t>
            </a:r>
            <a:endParaRPr kumimoji="0" 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166360" y="3988039"/>
            <a:ext cx="13928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andy soil</a:t>
            </a:r>
            <a:endParaRPr kumimoji="0" 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" name="Rectangle 36">
            <a:extLst>
              <a:ext uri="{FF2B5EF4-FFF2-40B4-BE49-F238E27FC236}">
                <a16:creationId xmlns:a16="http://schemas.microsoft.com/office/drawing/2014/main" id="{FDACFE2A-962E-3269-7B5B-150F1F712F7D}"/>
              </a:ext>
            </a:extLst>
          </p:cNvPr>
          <p:cNvSpPr/>
          <p:nvPr/>
        </p:nvSpPr>
        <p:spPr>
          <a:xfrm>
            <a:off x="9722627" y="6380277"/>
            <a:ext cx="2316973" cy="38247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" name="Foliennummernplatzhalter 31">
            <a:extLst>
              <a:ext uri="{FF2B5EF4-FFF2-40B4-BE49-F238E27FC236}">
                <a16:creationId xmlns:a16="http://schemas.microsoft.com/office/drawing/2014/main" id="{927B2D28-909C-4537-9BBB-37498BC2642C}"/>
              </a:ext>
            </a:extLst>
          </p:cNvPr>
          <p:cNvSpPr txBox="1">
            <a:spLocks/>
          </p:cNvSpPr>
          <p:nvPr/>
        </p:nvSpPr>
        <p:spPr>
          <a:xfrm>
            <a:off x="11671852" y="6492875"/>
            <a:ext cx="2743200" cy="365125"/>
          </a:xfrm>
          <a:prstGeom prst="rect">
            <a:avLst/>
          </a:prstGeom>
        </p:spPr>
        <p:txBody>
          <a:bodyPr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90339AA-5BF3-471A-89E3-6C4689393A32}" type="slidenum">
              <a:rPr kumimoji="0" lang="de-D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1390298" y="6367548"/>
            <a:ext cx="8791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 smtClean="0"/>
              <a:t>Supplementary</a:t>
            </a:r>
            <a:r>
              <a:rPr lang="de-DE" sz="1400" dirty="0" smtClean="0"/>
              <a:t> Fig. 1 </a:t>
            </a:r>
            <a:r>
              <a:rPr lang="en-CA" sz="1400" dirty="0"/>
              <a:t>Experimental procedure of hydroponic and sand pot experiments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4336724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 3" descr="C:\Users\s631610\AppData\Local\Packages\Microsoft.Windows.Photos_8wekyb3d8bbwe\TempState\ShareServiceTempFolder\Screenshot (149).jpeg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9798" y="1206039"/>
            <a:ext cx="5706745" cy="3581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Grafik 4" descr="C:\Users\s631610\AppData\Local\Packages\Microsoft.Windows.Photos_8wekyb3d8bbwe\TempState\ShareServiceTempFolder\Screenshot (150).jpeg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56543" y="1134601"/>
            <a:ext cx="5651500" cy="3724275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Rechteck 5"/>
          <p:cNvSpPr/>
          <p:nvPr/>
        </p:nvSpPr>
        <p:spPr>
          <a:xfrm>
            <a:off x="623456" y="4930314"/>
            <a:ext cx="872005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1400" dirty="0" smtClean="0">
                <a:latin typeface="Calibri" panose="020F0502020204030204" pitchFamily="34" charset="0"/>
                <a:ea typeface="SimSun" panose="02010600030101010101" pitchFamily="2" charset="-122"/>
              </a:rPr>
              <a:t>Supplementary Fig. 2 Soil </a:t>
            </a:r>
            <a:r>
              <a:rPr lang="en-CA" sz="1400" dirty="0">
                <a:latin typeface="Calibri" panose="020F0502020204030204" pitchFamily="34" charset="0"/>
                <a:ea typeface="SimSun" panose="02010600030101010101" pitchFamily="2" charset="-122"/>
              </a:rPr>
              <a:t>water capacity of the two field trials performed in </a:t>
            </a:r>
            <a:r>
              <a:rPr lang="en-CA" sz="1400" dirty="0" err="1">
                <a:latin typeface="Calibri" panose="020F0502020204030204" pitchFamily="34" charset="0"/>
                <a:ea typeface="SimSun" panose="02010600030101010101" pitchFamily="2" charset="-122"/>
              </a:rPr>
              <a:t>Groß</a:t>
            </a:r>
            <a:r>
              <a:rPr lang="en-CA" sz="1400" dirty="0">
                <a:latin typeface="Calibri" panose="020F0502020204030204" pitchFamily="34" charset="0"/>
                <a:ea typeface="SimSun" panose="02010600030101010101" pitchFamily="2" charset="-122"/>
              </a:rPr>
              <a:t> </a:t>
            </a:r>
            <a:r>
              <a:rPr lang="en-CA" sz="1400" dirty="0" err="1">
                <a:latin typeface="Calibri" panose="020F0502020204030204" pitchFamily="34" charset="0"/>
                <a:ea typeface="SimSun" panose="02010600030101010101" pitchFamily="2" charset="-122"/>
              </a:rPr>
              <a:t>Lüsewitz</a:t>
            </a:r>
            <a:r>
              <a:rPr lang="en-CA" sz="1400" dirty="0">
                <a:latin typeface="Calibri" panose="020F0502020204030204" pitchFamily="34" charset="0"/>
                <a:ea typeface="SimSun" panose="02010600030101010101" pitchFamily="2" charset="-122"/>
              </a:rPr>
              <a:t>. A: Soil water capacity in 2021, B: Soil water capacity in 2022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5067805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 descr="Ein Bild, das Text, Diagramm, Karte enthält.&#10;&#10;Automatisch generierte Beschreibun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6505" y="245629"/>
            <a:ext cx="5943600" cy="4504690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Rechteck 4"/>
          <p:cNvSpPr/>
          <p:nvPr/>
        </p:nvSpPr>
        <p:spPr>
          <a:xfrm>
            <a:off x="845126" y="4825134"/>
            <a:ext cx="9670473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sz="1400" dirty="0" smtClean="0">
                <a:latin typeface="Calibri" panose="020F0502020204030204" pitchFamily="34" charset="0"/>
                <a:ea typeface="SimSun" panose="02010600030101010101" pitchFamily="2" charset="-122"/>
              </a:rPr>
              <a:t>Supplementary Fig. 3 Transmission </a:t>
            </a:r>
            <a:r>
              <a:rPr lang="en-US" sz="1400" dirty="0">
                <a:latin typeface="Calibri" panose="020F0502020204030204" pitchFamily="34" charset="0"/>
                <a:ea typeface="SimSun" panose="02010600030101010101" pitchFamily="2" charset="-122"/>
              </a:rPr>
              <a:t>electron microscopy analysis of barley root tips of </a:t>
            </a:r>
            <a:r>
              <a:rPr lang="en-US" sz="1400" i="1" dirty="0" err="1">
                <a:latin typeface="Calibri" panose="020F0502020204030204" pitchFamily="34" charset="0"/>
                <a:ea typeface="SimSun" panose="02010600030101010101" pitchFamily="2" charset="-122"/>
              </a:rPr>
              <a:t>Hordeum</a:t>
            </a:r>
            <a:r>
              <a:rPr lang="en-US" sz="1400" i="1" dirty="0">
                <a:latin typeface="Calibri" panose="020F0502020204030204" pitchFamily="34" charset="0"/>
                <a:ea typeface="SimSun" panose="02010600030101010101" pitchFamily="2" charset="-122"/>
              </a:rPr>
              <a:t> </a:t>
            </a:r>
            <a:r>
              <a:rPr lang="en-US" sz="1400" i="1" dirty="0" err="1">
                <a:latin typeface="Calibri" panose="020F0502020204030204" pitchFamily="34" charset="0"/>
                <a:ea typeface="SimSun" panose="02010600030101010101" pitchFamily="2" charset="-122"/>
              </a:rPr>
              <a:t>vulgare</a:t>
            </a:r>
            <a:r>
              <a:rPr lang="en-US" sz="1400" dirty="0">
                <a:latin typeface="Calibri" panose="020F0502020204030204" pitchFamily="34" charset="0"/>
                <a:ea typeface="SimSun" panose="02010600030101010101" pitchFamily="2" charset="-122"/>
              </a:rPr>
              <a:t> </a:t>
            </a:r>
            <a:r>
              <a:rPr lang="en-US" sz="1400" dirty="0" smtClean="0">
                <a:latin typeface="Calibri" panose="020F0502020204030204" pitchFamily="34" charset="0"/>
                <a:ea typeface="SimSun" panose="02010600030101010101" pitchFamily="2" charset="-122"/>
              </a:rPr>
              <a:t>L. cv</a:t>
            </a:r>
            <a:r>
              <a:rPr lang="en-US" sz="1400" dirty="0">
                <a:latin typeface="Calibri" panose="020F0502020204030204" pitchFamily="34" charset="0"/>
                <a:ea typeface="SimSun" panose="02010600030101010101" pitchFamily="2" charset="-122"/>
              </a:rPr>
              <a:t>. </a:t>
            </a:r>
            <a:r>
              <a:rPr lang="en-US" sz="1400" dirty="0" err="1">
                <a:latin typeface="Calibri" panose="020F0502020204030204" pitchFamily="34" charset="0"/>
                <a:ea typeface="SimSun" panose="02010600030101010101" pitchFamily="2" charset="-122"/>
              </a:rPr>
              <a:t>Morex</a:t>
            </a:r>
            <a:r>
              <a:rPr lang="en-US" sz="1400" dirty="0">
                <a:latin typeface="Calibri" panose="020F0502020204030204" pitchFamily="34" charset="0"/>
                <a:ea typeface="SimSun" panose="02010600030101010101" pitchFamily="2" charset="-122"/>
              </a:rPr>
              <a:t>. Light- (a, f) and transmission electron microscopy images (b-e, g-r) of longitudinal section of root tips of plants grown under control conditions (a, b, c, g, h, k, l, o, p) and drought stress treatment with 12.5% (w/v) PEG 6000 (d, e, f, I, j, m, n, q, r). Ultrastructure analysis of stele cells (b-e, o-r), epidermis (g-j) and cortex cells (k-n). ER, endoplasmic reticulum; M, mitochondria; N, nucleus; P, plastid, V, vacuole.</a:t>
            </a:r>
            <a:endParaRPr lang="en-US" sz="1400" dirty="0">
              <a:latin typeface="Times New Roman" panose="02020603050405020304" pitchFamily="18" charset="0"/>
              <a:ea typeface="SimSun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4153293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5</Words>
  <Application>Microsoft Office PowerPoint</Application>
  <PresentationFormat>Breitbild</PresentationFormat>
  <Paragraphs>33</Paragraphs>
  <Slides>4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10" baseType="lpstr">
      <vt:lpstr>SimSun</vt:lpstr>
      <vt:lpstr>Arial</vt:lpstr>
      <vt:lpstr>Calibri</vt:lpstr>
      <vt:lpstr>Calibri Light</vt:lpstr>
      <vt:lpstr>Times New Roman</vt:lpstr>
      <vt:lpstr>Office</vt:lpstr>
      <vt:lpstr>Supplementary Material 1</vt:lpstr>
      <vt:lpstr>PowerPoint-Präsentation</vt:lpstr>
      <vt:lpstr>PowerPoint-Präsentation</vt:lpstr>
      <vt:lpstr>PowerPoint-Präsentation</vt:lpstr>
    </vt:vector>
  </TitlesOfParts>
  <Company>SKW Stickstoffwerke Piesteritz Gmb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Material 1</dc:title>
  <dc:creator>Töpfer, Veronic</dc:creator>
  <cp:lastModifiedBy>Töpfer, Veronic</cp:lastModifiedBy>
  <cp:revision>1</cp:revision>
  <dcterms:created xsi:type="dcterms:W3CDTF">2024-04-02T13:26:24Z</dcterms:created>
  <dcterms:modified xsi:type="dcterms:W3CDTF">2024-04-02T13:26:32Z</dcterms:modified>
</cp:coreProperties>
</file>